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994D12-22D1-475B-857C-56CB991A22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0DDA5-144A-4688-96A3-9B820F8B26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0AF71-CC9F-43E3-B2F2-F505B250E0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2EB26-E56B-4C24-AC2A-DD8D75C4EF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839C7-ED88-4F0E-967D-20EF388790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C8CF3-AEC4-47E2-A598-7C8FD91D2E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0A5B1-F42F-4E49-ADD8-5C969A3261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8F418-D8E7-49F7-B9F3-D8BBB5F72A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52967-0D97-4A7F-8107-F618656962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C503C-AE1C-4827-B760-6FFC436905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95238-EEFE-4D99-91EE-090AD4E2F8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D185A-AE40-4331-9293-C5752B7A28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3FC79B-8512-4963-B5FC-BF3E314B7AF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salad.dna.affrc.go.jp/" TargetMode="Externa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2.png"/><Relationship Id="rId10" Type="http://schemas.openxmlformats.org/officeDocument/2006/relationships/image" Target="../media/image1.png"/><Relationship Id="rId11" Type="http://schemas.openxmlformats.org/officeDocument/2006/relationships/image" Target="../media/image2.png"/><Relationship Id="rId12" Type="http://schemas.openxmlformats.org/officeDocument/2006/relationships/image" Target="../media/image2.png"/><Relationship Id="rId13" Type="http://schemas.openxmlformats.org/officeDocument/2006/relationships/image" Target="../media/image2.png"/><Relationship Id="rId14" Type="http://schemas.openxmlformats.org/officeDocument/2006/relationships/image" Target="../media/image3.png"/><Relationship Id="rId1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17560" y="6313320"/>
            <a:ext cx="41227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l Figure 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Expression of sHsps genes during  anther development in rice. Analysis was performed at RAP-DB (</a:t>
            </a:r>
            <a:r>
              <a:rPr b="0" lang="en-US" sz="1200" spc="-1" strike="noStrike" u="sng">
                <a:solidFill>
                  <a:srgbClr val="009999"/>
                </a:solidFill>
                <a:uFillTx/>
                <a:latin typeface="Times New Roman"/>
                <a:hlinkClick r:id="rId1"/>
              </a:rPr>
              <a:t>http://salad.dna.affrc.go.jp/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CGViewer/MicroArrayPollen/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490760" y="1025640"/>
            <a:ext cx="4365000" cy="5943600"/>
            <a:chOff x="1490760" y="1025640"/>
            <a:chExt cx="4365000" cy="5943600"/>
          </a:xfrm>
        </p:grpSpPr>
        <p:sp>
          <p:nvSpPr>
            <p:cNvPr id="43" name=""/>
            <p:cNvSpPr/>
            <p:nvPr/>
          </p:nvSpPr>
          <p:spPr>
            <a:xfrm>
              <a:off x="4505760" y="2013120"/>
              <a:ext cx="80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6.9A-C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505400" y="1111320"/>
              <a:ext cx="720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8.0-C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505400" y="1420920"/>
              <a:ext cx="720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7.4-C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505760" y="1266840"/>
              <a:ext cx="80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7.9A-C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505400" y="1557360"/>
              <a:ext cx="720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7.7-C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505400" y="1701720"/>
              <a:ext cx="796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6.9C-C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505400" y="1857240"/>
              <a:ext cx="796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6.9B-C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515120" y="2612880"/>
              <a:ext cx="878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6.6-CVII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505400" y="3586320"/>
              <a:ext cx="698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26.7- 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505400" y="3922560"/>
              <a:ext cx="746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24.0-M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514760" y="4086360"/>
              <a:ext cx="746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26.2-M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505760" y="2155680"/>
              <a:ext cx="758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9.0-CI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505760" y="2309760"/>
              <a:ext cx="758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8.0-CI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505040" y="3745080"/>
              <a:ext cx="756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6.0- P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505760" y="3079800"/>
              <a:ext cx="80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7.8-CX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505400" y="3416400"/>
              <a:ext cx="752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23.2-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505400" y="3259080"/>
              <a:ext cx="752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21.8-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0" name=""/>
            <p:cNvGrpSpPr/>
            <p:nvPr/>
          </p:nvGrpSpPr>
          <p:grpSpPr>
            <a:xfrm>
              <a:off x="1539000" y="1141560"/>
              <a:ext cx="2960640" cy="3498840"/>
              <a:chOff x="1539000" y="1141560"/>
              <a:chExt cx="2960640" cy="3498840"/>
            </a:xfrm>
          </p:grpSpPr>
          <p:sp>
            <p:nvSpPr>
              <p:cNvPr id="61" name=""/>
              <p:cNvSpPr/>
              <p:nvPr/>
            </p:nvSpPr>
            <p:spPr>
              <a:xfrm>
                <a:off x="1539000" y="4224240"/>
                <a:ext cx="2960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MEI   TET   UN    BC                   TC   MEI  TET U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2" name="" descr=""/>
              <p:cNvPicPr/>
              <p:nvPr/>
            </p:nvPicPr>
            <p:blipFill>
              <a:blip r:embed="rId2"/>
              <a:srcRect l="22884" t="65734" r="0" b="21287"/>
              <a:stretch/>
            </p:blipFill>
            <p:spPr>
              <a:xfrm>
                <a:off x="1587600" y="1146240"/>
                <a:ext cx="2887560" cy="1033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" name="" descr=""/>
              <p:cNvPicPr/>
              <p:nvPr/>
            </p:nvPicPr>
            <p:blipFill>
              <a:blip r:embed="rId3"/>
              <a:srcRect l="23069" t="38034" r="510" b="59942"/>
              <a:stretch/>
            </p:blipFill>
            <p:spPr>
              <a:xfrm>
                <a:off x="1606680" y="3775320"/>
                <a:ext cx="2854080" cy="152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4" name="" descr=""/>
              <p:cNvPicPr/>
              <p:nvPr/>
            </p:nvPicPr>
            <p:blipFill>
              <a:blip r:embed="rId4"/>
              <a:srcRect l="22884" t="21433" r="0" b="76721"/>
              <a:stretch/>
            </p:blipFill>
            <p:spPr>
              <a:xfrm>
                <a:off x="1600200" y="3273480"/>
                <a:ext cx="2879640" cy="13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5" name="" descr=""/>
              <p:cNvPicPr/>
              <p:nvPr/>
            </p:nvPicPr>
            <p:blipFill>
              <a:blip r:embed="rId5"/>
              <a:srcRect l="23149" t="25163" r="0" b="72861"/>
              <a:stretch/>
            </p:blipFill>
            <p:spPr>
              <a:xfrm>
                <a:off x="1600200" y="3435480"/>
                <a:ext cx="2879640" cy="149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6" name="" descr=""/>
              <p:cNvPicPr/>
              <p:nvPr/>
            </p:nvPicPr>
            <p:blipFill>
              <a:blip r:embed="rId6"/>
              <a:srcRect l="22933" t="38261" r="0" b="59715"/>
              <a:stretch/>
            </p:blipFill>
            <p:spPr>
              <a:xfrm>
                <a:off x="1600200" y="3592440"/>
                <a:ext cx="2876400" cy="152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7" name="" descr=""/>
              <p:cNvPicPr/>
              <p:nvPr/>
            </p:nvPicPr>
            <p:blipFill>
              <a:blip r:embed="rId7"/>
              <a:srcRect l="23202" t="45765" r="0" b="50429"/>
              <a:stretch/>
            </p:blipFill>
            <p:spPr>
              <a:xfrm>
                <a:off x="1611360" y="3957840"/>
                <a:ext cx="2868480" cy="287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8" name="" descr=""/>
              <p:cNvPicPr/>
              <p:nvPr/>
            </p:nvPicPr>
            <p:blipFill>
              <a:blip r:embed="rId8"/>
              <a:srcRect l="22933" t="56638" r="0" b="39572"/>
              <a:stretch/>
            </p:blipFill>
            <p:spPr>
              <a:xfrm>
                <a:off x="1593720" y="2181240"/>
                <a:ext cx="2876760" cy="295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9" name="" descr=""/>
              <p:cNvPicPr/>
              <p:nvPr/>
            </p:nvPicPr>
            <p:blipFill>
              <a:blip r:embed="rId9"/>
              <a:srcRect l="22884" t="30503" r="0" b="67289"/>
              <a:stretch/>
            </p:blipFill>
            <p:spPr>
              <a:xfrm>
                <a:off x="1590840" y="2778120"/>
                <a:ext cx="2879640" cy="166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"/>
              <p:cNvSpPr/>
              <p:nvPr/>
            </p:nvSpPr>
            <p:spPr>
              <a:xfrm>
                <a:off x="1603440" y="4268880"/>
                <a:ext cx="2828880" cy="1429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603440" y="4440240"/>
                <a:ext cx="2828880" cy="1429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606320" y="4394160"/>
                <a:ext cx="2640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      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llen                                    Tapetu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3" name="" descr=""/>
              <p:cNvPicPr/>
              <p:nvPr/>
            </p:nvPicPr>
            <p:blipFill>
              <a:blip r:embed="rId10"/>
              <a:srcRect l="23432" t="64099" r="1682" b="34001"/>
              <a:stretch/>
            </p:blipFill>
            <p:spPr>
              <a:xfrm>
                <a:off x="1609560" y="2637000"/>
                <a:ext cx="2805120" cy="155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4" name="" descr=""/>
              <p:cNvPicPr/>
              <p:nvPr/>
            </p:nvPicPr>
            <p:blipFill>
              <a:blip r:embed="rId11"/>
              <a:srcRect l="23069" t="39810" r="0" b="58290"/>
              <a:stretch/>
            </p:blipFill>
            <p:spPr>
              <a:xfrm>
                <a:off x="1606680" y="3089520"/>
                <a:ext cx="2873160" cy="142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5" name="" descr=""/>
              <p:cNvPicPr/>
              <p:nvPr/>
            </p:nvPicPr>
            <p:blipFill>
              <a:blip r:embed="rId12"/>
              <a:srcRect l="23069" t="36004" r="0" b="61842"/>
              <a:stretch/>
            </p:blipFill>
            <p:spPr>
              <a:xfrm>
                <a:off x="1606680" y="2470320"/>
                <a:ext cx="2873160" cy="162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6" name="" descr=""/>
              <p:cNvPicPr/>
              <p:nvPr/>
            </p:nvPicPr>
            <p:blipFill>
              <a:blip r:embed="rId13"/>
              <a:srcRect l="22884" t="19786" r="510" b="78492"/>
              <a:stretch/>
            </p:blipFill>
            <p:spPr>
              <a:xfrm>
                <a:off x="1600200" y="2949480"/>
                <a:ext cx="2860560" cy="130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7" name=""/>
              <p:cNvSpPr/>
              <p:nvPr/>
            </p:nvSpPr>
            <p:spPr>
              <a:xfrm>
                <a:off x="1604880" y="1144800"/>
                <a:ext cx="2828880" cy="3095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3606840" y="1141560"/>
                <a:ext cx="1440" cy="326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" name=""/>
            <p:cNvSpPr/>
            <p:nvPr/>
          </p:nvSpPr>
          <p:spPr>
            <a:xfrm>
              <a:off x="5305320" y="1257480"/>
              <a:ext cx="0" cy="885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305320" y="2228760"/>
              <a:ext cx="0" cy="16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315040" y="3352680"/>
              <a:ext cx="0" cy="16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315040" y="4019400"/>
              <a:ext cx="0" cy="16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405760" y="1550880"/>
              <a:ext cx="33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405760" y="216072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405760" y="3294000"/>
              <a:ext cx="37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405400" y="3960720"/>
              <a:ext cx="36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515120" y="2774880"/>
              <a:ext cx="878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7.9B-CI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505760" y="2465280"/>
              <a:ext cx="764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8.8-CV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"/>
            <p:cNvGrpSpPr/>
            <p:nvPr/>
          </p:nvGrpSpPr>
          <p:grpSpPr>
            <a:xfrm>
              <a:off x="1698480" y="5108400"/>
              <a:ext cx="1472040" cy="1184400"/>
              <a:chOff x="1698480" y="5108400"/>
              <a:chExt cx="1472040" cy="1184400"/>
            </a:xfrm>
          </p:grpSpPr>
          <p:pic>
            <p:nvPicPr>
              <p:cNvPr id="90" name="" descr=""/>
              <p:cNvPicPr/>
              <p:nvPr/>
            </p:nvPicPr>
            <p:blipFill>
              <a:blip r:embed="rId14"/>
              <a:srcRect l="62230" t="47147" r="35275" b="41430"/>
              <a:stretch/>
            </p:blipFill>
            <p:spPr>
              <a:xfrm>
                <a:off x="1698480" y="5121000"/>
                <a:ext cx="238320" cy="1171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"/>
              <p:cNvSpPr/>
              <p:nvPr/>
            </p:nvSpPr>
            <p:spPr>
              <a:xfrm>
                <a:off x="1974960" y="5108400"/>
                <a:ext cx="1195560" cy="115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lt;1e+2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gt;=1e+2.0, &lt;1e+2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gt;=1e+2.5, &lt; 1e+3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gt;=1e+3.0, &lt;1e+3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gt;=1e+3.5, &lt;1e+4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gt;=1e+4.0, &lt;1e+4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gt;=1e+4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2" name=""/>
            <p:cNvSpPr/>
            <p:nvPr/>
          </p:nvSpPr>
          <p:spPr>
            <a:xfrm>
              <a:off x="1694520" y="4865760"/>
              <a:ext cx="180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Scale for expression leve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505760" y="2932200"/>
              <a:ext cx="764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Hsp18.8-C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990960" y="4948200"/>
              <a:ext cx="1864800" cy="115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tages of anther developm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EI – meiosis microspo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T – tetrad microspo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N  - uninuclear microspo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C - bicellular polle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C - tricellular polle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490760" y="1025640"/>
              <a:ext cx="4336920" cy="5943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28T11:01:04Z</dcterms:created>
  <dc:creator>ag1</dc:creator>
  <dc:description/>
  <dc:language>en-US</dc:language>
  <cp:lastModifiedBy>ag1</cp:lastModifiedBy>
  <dcterms:modified xsi:type="dcterms:W3CDTF">2009-08-03T07:31:56Z</dcterms:modified>
  <cp:revision>20</cp:revision>
  <dc:subject/>
  <dc:title>Slide 1</dc:title>
</cp:coreProperties>
</file>